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AF9F91-A0B2-4460-A618-E0968E0163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75507-EEBF-408F-A2E1-48F8186F31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78068-635A-4500-B005-69AE80C179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1F2C74-17CC-4BA2-8AEF-DA0E47D731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A89EE-F633-4FCC-B27B-4671A05AED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957DF-9D85-4698-BD4C-450099346C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664B61-4DFC-45E7-82E2-B38543FBB4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86C0F-11C3-45AA-A4A3-2686A027D1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869E6-DEA8-4F5E-8E2E-A73712D7BE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1E5D4-8C3A-4BE5-A57C-2AC9C5662F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65FB7-CBD5-4BD1-90CA-3585F7E268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5D3BBF-B184-4EB2-8442-87FD3E9EC1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26E4B1-92C9-4C92-B749-4E2A1C83AB62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32640" y="696960"/>
            <a:ext cx="2221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631800" y="5118120"/>
            <a:ext cx="5907240" cy="107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3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ffects of amino acid starvation (AS) on autophagy in endothelial cells detected by LC3 immunofluorescence. Amino acid starvation was induced by treating cells with Hank’s Balanced Salt Solution for 4 hr. Data are mean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SEM. *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&lt; 0.05, unpaired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test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= 3)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430360" y="1433520"/>
            <a:ext cx="52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046760" y="143352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A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1889280" y="1785960"/>
          <a:ext cx="1542960" cy="1197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89280" y="1785960"/>
                    <a:ext cx="1542960" cy="1197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3471840" y="1776240"/>
          <a:ext cx="1542960" cy="12020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471840" y="1776240"/>
                    <a:ext cx="1542960" cy="1202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"/>
          <p:cNvSpPr/>
          <p:nvPr/>
        </p:nvSpPr>
        <p:spPr>
          <a:xfrm>
            <a:off x="2050920" y="4172040"/>
            <a:ext cx="459000" cy="234720"/>
          </a:xfrm>
          <a:prstGeom prst="rect">
            <a:avLst/>
          </a:prstGeom>
          <a:solidFill>
            <a:srgbClr val="000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050920" y="4172040"/>
            <a:ext cx="459000" cy="231840"/>
          </a:xfrm>
          <a:custGeom>
            <a:avLst/>
            <a:gdLst/>
            <a:ahLst/>
            <a:rect l="l" t="t" r="r" b="b"/>
            <a:pathLst>
              <a:path w="599" h="301">
                <a:moveTo>
                  <a:pt x="0" y="301"/>
                </a:moveTo>
                <a:lnTo>
                  <a:pt x="0" y="301"/>
                </a:lnTo>
                <a:lnTo>
                  <a:pt x="0" y="0"/>
                </a:lnTo>
                <a:lnTo>
                  <a:pt x="599" y="0"/>
                </a:lnTo>
                <a:lnTo>
                  <a:pt x="599" y="301"/>
                </a:lnTo>
              </a:path>
            </a:pathLst>
          </a:cu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166840" y="4135320"/>
            <a:ext cx="22860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81320" y="4135320"/>
            <a:ext cx="0" cy="3672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739960" y="3652920"/>
            <a:ext cx="459000" cy="7538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739960" y="3652920"/>
            <a:ext cx="459000" cy="750960"/>
          </a:xfrm>
          <a:custGeom>
            <a:avLst/>
            <a:gdLst/>
            <a:ahLst/>
            <a:rect l="l" t="t" r="r" b="b"/>
            <a:pathLst>
              <a:path w="599" h="977">
                <a:moveTo>
                  <a:pt x="0" y="977"/>
                </a:moveTo>
                <a:lnTo>
                  <a:pt x="0" y="977"/>
                </a:lnTo>
                <a:lnTo>
                  <a:pt x="0" y="0"/>
                </a:lnTo>
                <a:lnTo>
                  <a:pt x="599" y="0"/>
                </a:lnTo>
                <a:lnTo>
                  <a:pt x="599" y="977"/>
                </a:lnTo>
              </a:path>
            </a:pathLst>
          </a:cu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854440" y="3603600"/>
            <a:ext cx="23004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970360" y="3603600"/>
            <a:ext cx="0" cy="4932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936800" y="4406760"/>
            <a:ext cx="137628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129040" y="4478400"/>
            <a:ext cx="29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864880" y="4478400"/>
            <a:ext cx="21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1936800" y="3485880"/>
            <a:ext cx="0" cy="9205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>
            <a:off x="1910880" y="440676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766160" y="43178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1910880" y="422280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681200" y="41338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>
            <a:off x="1910880" y="403848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681200" y="39495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H="1">
            <a:off x="1910880" y="385452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681200" y="37656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H="1">
            <a:off x="1910880" y="367020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681200" y="35812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H="1">
            <a:off x="1910880" y="348624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596600" y="339732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892080" y="3842640"/>
            <a:ext cx="1040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LC3+ cells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094280" y="4268880"/>
            <a:ext cx="458640" cy="137880"/>
          </a:xfrm>
          <a:prstGeom prst="rect">
            <a:avLst/>
          </a:prstGeom>
          <a:solidFill>
            <a:srgbClr val="000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094280" y="4268880"/>
            <a:ext cx="457200" cy="135000"/>
          </a:xfrm>
          <a:custGeom>
            <a:avLst/>
            <a:gdLst/>
            <a:ahLst/>
            <a:rect l="l" t="t" r="r" b="b"/>
            <a:pathLst>
              <a:path w="599" h="175">
                <a:moveTo>
                  <a:pt x="0" y="175"/>
                </a:moveTo>
                <a:lnTo>
                  <a:pt x="0" y="175"/>
                </a:lnTo>
                <a:lnTo>
                  <a:pt x="0" y="0"/>
                </a:lnTo>
                <a:lnTo>
                  <a:pt x="599" y="0"/>
                </a:lnTo>
                <a:lnTo>
                  <a:pt x="599" y="175"/>
                </a:lnTo>
              </a:path>
            </a:pathLst>
          </a:cu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208400" y="4241880"/>
            <a:ext cx="22860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322880" y="4241880"/>
            <a:ext cx="0" cy="2700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781520" y="3773520"/>
            <a:ext cx="458640" cy="6332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781520" y="3773520"/>
            <a:ext cx="458640" cy="630360"/>
          </a:xfrm>
          <a:custGeom>
            <a:avLst/>
            <a:gdLst/>
            <a:ahLst/>
            <a:rect l="l" t="t" r="r" b="b"/>
            <a:pathLst>
              <a:path w="599" h="821">
                <a:moveTo>
                  <a:pt x="0" y="821"/>
                </a:moveTo>
                <a:lnTo>
                  <a:pt x="0" y="821"/>
                </a:lnTo>
                <a:lnTo>
                  <a:pt x="0" y="0"/>
                </a:lnTo>
                <a:lnTo>
                  <a:pt x="599" y="0"/>
                </a:lnTo>
                <a:lnTo>
                  <a:pt x="599" y="821"/>
                </a:lnTo>
              </a:path>
            </a:pathLst>
          </a:cu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897440" y="3616200"/>
            <a:ext cx="22860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5011560" y="3616200"/>
            <a:ext cx="0" cy="15732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978360" y="4406760"/>
            <a:ext cx="13777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3978360" y="3485880"/>
            <a:ext cx="0" cy="9205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H="1">
            <a:off x="3952440" y="440676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799800" y="43084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H="1">
            <a:off x="3952440" y="422280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799800" y="41241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H="1">
            <a:off x="3952440" y="403848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799800" y="39402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H="1">
            <a:off x="3952440" y="385452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799800" y="37558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H="1">
            <a:off x="3952440" y="367020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799800" y="35719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H="1">
            <a:off x="3952440" y="3486240"/>
            <a:ext cx="255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714840" y="33876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rot="16200000">
            <a:off x="2877120" y="3840120"/>
            <a:ext cx="1410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LC3 puncta per cel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838240" y="3314880"/>
            <a:ext cx="291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Tahoma"/>
                <a:ea typeface="宋体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876560" y="3305160"/>
            <a:ext cx="291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Tahoma"/>
                <a:ea typeface="宋体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853640" y="1760400"/>
            <a:ext cx="87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  <a:ea typeface="宋体"/>
              </a:rPr>
              <a:t>LC3</a:t>
            </a:r>
            <a:r>
              <a:rPr b="1" lang="en-US" sz="1200" spc="-1" strike="noStrike">
                <a:solidFill>
                  <a:srgbClr val="ffffff"/>
                </a:solidFill>
                <a:latin typeface="Arial"/>
                <a:ea typeface="宋体"/>
              </a:rPr>
              <a:t>/</a:t>
            </a:r>
            <a:r>
              <a:rPr b="1" lang="en-US" sz="1200" spc="-1" strike="noStrike">
                <a:solidFill>
                  <a:srgbClr val="0066ff"/>
                </a:solidFill>
                <a:latin typeface="Arial"/>
                <a:ea typeface="宋体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192920" y="4478400"/>
            <a:ext cx="29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4928760" y="4478400"/>
            <a:ext cx="21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"/>
          <p:cNvSpPr/>
          <p:nvPr/>
        </p:nvSpPr>
        <p:spPr>
          <a:xfrm>
            <a:off x="409320" y="611280"/>
            <a:ext cx="2289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841320" y="7278120"/>
            <a:ext cx="5176800" cy="139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Immunofluorescence images of LC3 and corresponding quantitative data showing that short-term treatment with a high concentration of 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(60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 for 2 hr) did not trigger autophagic responses, whereas flow-adapted cells showed increased autophagy. Flow-induced increase in autophagy was blocked in the presence of 3-MA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ata are mean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SEM. *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&lt; 0.05 one-way ANOVA (n = 4). NS, non-significan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6" name="" descr=""/>
          <p:cNvPicPr/>
          <p:nvPr/>
        </p:nvPicPr>
        <p:blipFill>
          <a:blip r:embed="rId1"/>
          <a:stretch/>
        </p:blipFill>
        <p:spPr>
          <a:xfrm>
            <a:off x="3922560" y="2697120"/>
            <a:ext cx="1198800" cy="1109880"/>
          </a:xfrm>
          <a:prstGeom prst="rect">
            <a:avLst/>
          </a:prstGeom>
          <a:ln w="0">
            <a:noFill/>
          </a:ln>
        </p:spPr>
      </p:pic>
      <p:pic>
        <p:nvPicPr>
          <p:cNvPr id="507" name="" descr=""/>
          <p:cNvPicPr/>
          <p:nvPr/>
        </p:nvPicPr>
        <p:blipFill>
          <a:blip r:embed="rId2"/>
          <a:stretch/>
        </p:blipFill>
        <p:spPr>
          <a:xfrm>
            <a:off x="2690640" y="2697120"/>
            <a:ext cx="1192320" cy="1109880"/>
          </a:xfrm>
          <a:prstGeom prst="rect">
            <a:avLst/>
          </a:prstGeom>
          <a:ln w="0">
            <a:noFill/>
          </a:ln>
        </p:spPr>
      </p:pic>
      <p:pic>
        <p:nvPicPr>
          <p:cNvPr id="508" name="" descr=""/>
          <p:cNvPicPr/>
          <p:nvPr/>
        </p:nvPicPr>
        <p:blipFill>
          <a:blip r:embed="rId3"/>
          <a:stretch/>
        </p:blipFill>
        <p:spPr>
          <a:xfrm>
            <a:off x="3919680" y="1536840"/>
            <a:ext cx="1191960" cy="1114200"/>
          </a:xfrm>
          <a:prstGeom prst="rect">
            <a:avLst/>
          </a:prstGeom>
          <a:ln w="0">
            <a:noFill/>
          </a:ln>
        </p:spPr>
      </p:pic>
      <p:pic>
        <p:nvPicPr>
          <p:cNvPr id="509" name="" descr=""/>
          <p:cNvPicPr/>
          <p:nvPr/>
        </p:nvPicPr>
        <p:blipFill>
          <a:blip r:embed="rId4"/>
          <a:stretch/>
        </p:blipFill>
        <p:spPr>
          <a:xfrm>
            <a:off x="1469880" y="2687760"/>
            <a:ext cx="1187640" cy="1109520"/>
          </a:xfrm>
          <a:prstGeom prst="rect">
            <a:avLst/>
          </a:prstGeom>
          <a:ln w="0">
            <a:noFill/>
          </a:ln>
        </p:spPr>
      </p:pic>
      <p:pic>
        <p:nvPicPr>
          <p:cNvPr id="510" name="" descr=""/>
          <p:cNvPicPr/>
          <p:nvPr/>
        </p:nvPicPr>
        <p:blipFill>
          <a:blip r:embed="rId5"/>
          <a:stretch/>
        </p:blipFill>
        <p:spPr>
          <a:xfrm>
            <a:off x="2690640" y="1544760"/>
            <a:ext cx="1204920" cy="1103040"/>
          </a:xfrm>
          <a:prstGeom prst="rect">
            <a:avLst/>
          </a:prstGeom>
          <a:ln w="0">
            <a:noFill/>
          </a:ln>
        </p:spPr>
      </p:pic>
      <p:pic>
        <p:nvPicPr>
          <p:cNvPr id="511" name="" descr=""/>
          <p:cNvPicPr/>
          <p:nvPr/>
        </p:nvPicPr>
        <p:blipFill>
          <a:blip r:embed="rId6"/>
          <a:stretch/>
        </p:blipFill>
        <p:spPr>
          <a:xfrm>
            <a:off x="1457280" y="1544760"/>
            <a:ext cx="1204920" cy="1103040"/>
          </a:xfrm>
          <a:prstGeom prst="rect">
            <a:avLst/>
          </a:prstGeom>
          <a:ln w="0">
            <a:noFill/>
          </a:ln>
        </p:spPr>
      </p:pic>
      <p:sp>
        <p:nvSpPr>
          <p:cNvPr id="512" name=""/>
          <p:cNvSpPr/>
          <p:nvPr/>
        </p:nvSpPr>
        <p:spPr>
          <a:xfrm>
            <a:off x="962640" y="2014560"/>
            <a:ext cx="4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887400" y="3116160"/>
            <a:ext cx="55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-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1823040" y="121752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3020040" y="1217520"/>
            <a:ext cx="5065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3980520" y="1217520"/>
            <a:ext cx="107820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+ F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1514520" y="5643720"/>
            <a:ext cx="5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1568520" y="4356000"/>
            <a:ext cx="0" cy="1679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1832040" y="5423040"/>
            <a:ext cx="303120" cy="612720"/>
          </a:xfrm>
          <a:prstGeom prst="rect">
            <a:avLst/>
          </a:prstGeom>
          <a:solidFill>
            <a:srgbClr val="80808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2340000" y="5342040"/>
            <a:ext cx="303120" cy="693720"/>
          </a:xfrm>
          <a:prstGeom prst="rect">
            <a:avLst/>
          </a:prstGeom>
          <a:solidFill>
            <a:srgbClr val="80808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2868480" y="4584600"/>
            <a:ext cx="303480" cy="1451160"/>
          </a:xfrm>
          <a:prstGeom prst="rect">
            <a:avLst/>
          </a:prstGeom>
          <a:solidFill>
            <a:srgbClr val="80808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3719520" y="5700600"/>
            <a:ext cx="301680" cy="335160"/>
          </a:xfrm>
          <a:prstGeom prst="rect">
            <a:avLst/>
          </a:prstGeom>
          <a:solidFill>
            <a:srgbClr val="80808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4246560" y="5522760"/>
            <a:ext cx="303120" cy="513000"/>
          </a:xfrm>
          <a:prstGeom prst="rect">
            <a:avLst/>
          </a:prstGeom>
          <a:solidFill>
            <a:srgbClr val="80808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4754520" y="5564160"/>
            <a:ext cx="303120" cy="471600"/>
          </a:xfrm>
          <a:prstGeom prst="rect">
            <a:avLst/>
          </a:prstGeom>
          <a:solidFill>
            <a:srgbClr val="80808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 flipV="1">
            <a:off x="1989000" y="5335200"/>
            <a:ext cx="0" cy="82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 flipV="1">
            <a:off x="2486160" y="5198760"/>
            <a:ext cx="0" cy="142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 flipV="1">
            <a:off x="3014640" y="4495680"/>
            <a:ext cx="0" cy="84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 flipV="1">
            <a:off x="3875040" y="5525640"/>
            <a:ext cx="0" cy="1746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 flipV="1">
            <a:off x="4403880" y="5467320"/>
            <a:ext cx="0" cy="46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 flipV="1">
            <a:off x="4911840" y="5454720"/>
            <a:ext cx="0" cy="109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1514520" y="5253120"/>
            <a:ext cx="5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1514520" y="4862520"/>
            <a:ext cx="5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>
            <a:off x="1514520" y="4471920"/>
            <a:ext cx="5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1514520" y="6039000"/>
            <a:ext cx="5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>
            <a:off x="1568520" y="6035760"/>
            <a:ext cx="3724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1900080" y="5335560"/>
            <a:ext cx="176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2398680" y="5194440"/>
            <a:ext cx="176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2927520" y="4491000"/>
            <a:ext cx="176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3787920" y="5526000"/>
            <a:ext cx="176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>
            <a:off x="4316400" y="5467320"/>
            <a:ext cx="174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4822920" y="5454720"/>
            <a:ext cx="176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2311920" y="6678720"/>
            <a:ext cx="4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4198680" y="6678720"/>
            <a:ext cx="55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-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1677240" y="611028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2254680" y="6110280"/>
            <a:ext cx="5065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>
            <a:off x="2747160" y="6110280"/>
            <a:ext cx="595080" cy="48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3569400" y="611028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4166280" y="6110280"/>
            <a:ext cx="5065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>
            <a:off x="4649040" y="6110280"/>
            <a:ext cx="595080" cy="48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"/>
          <p:cNvSpPr/>
          <p:nvPr/>
        </p:nvSpPr>
        <p:spPr>
          <a:xfrm>
            <a:off x="1752480" y="6607080"/>
            <a:ext cx="1505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"/>
          <p:cNvSpPr/>
          <p:nvPr/>
        </p:nvSpPr>
        <p:spPr>
          <a:xfrm>
            <a:off x="3664080" y="6607080"/>
            <a:ext cx="1504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"/>
          <p:cNvSpPr/>
          <p:nvPr/>
        </p:nvSpPr>
        <p:spPr>
          <a:xfrm>
            <a:off x="1391400" y="59421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>
            <a:off x="1306800" y="55497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1306800" y="51642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1306800" y="47703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1306800" y="43750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Rectangle 57"/>
          <p:cNvSpPr/>
          <p:nvPr/>
        </p:nvSpPr>
        <p:spPr>
          <a:xfrm rot="16200000">
            <a:off x="505440" y="5126040"/>
            <a:ext cx="114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LC3+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cells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3772080" y="5295960"/>
            <a:ext cx="1199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4147920" y="501480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1854360" y="4340160"/>
            <a:ext cx="1199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2338560" y="40654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2" name=""/>
          <p:cNvSpPr/>
          <p:nvPr/>
        </p:nvSpPr>
        <p:spPr>
          <a:xfrm>
            <a:off x="342000" y="1049400"/>
            <a:ext cx="234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X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606600" y="3773520"/>
            <a:ext cx="5668920" cy="58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3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estern blot showing the effect of Atg5 gene silencing by two different siRNA sequences on the protein level of Atg5. NC, non-targeting contro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4" name="" descr=""/>
          <p:cNvPicPr/>
          <p:nvPr/>
        </p:nvPicPr>
        <p:blipFill>
          <a:blip r:embed="rId1"/>
          <a:stretch/>
        </p:blipFill>
        <p:spPr>
          <a:xfrm>
            <a:off x="2147760" y="2433600"/>
            <a:ext cx="1285920" cy="843120"/>
          </a:xfrm>
          <a:prstGeom prst="rect">
            <a:avLst/>
          </a:prstGeom>
          <a:ln w="0">
            <a:noFill/>
          </a:ln>
        </p:spPr>
      </p:pic>
      <p:sp>
        <p:nvSpPr>
          <p:cNvPr id="565" name=""/>
          <p:cNvSpPr/>
          <p:nvPr/>
        </p:nvSpPr>
        <p:spPr>
          <a:xfrm>
            <a:off x="4624200" y="252900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tg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4611600" y="2886120"/>
            <a:ext cx="67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2338200" y="219564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2849400" y="219564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tg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>
            <a:off x="2381400" y="2152800"/>
            <a:ext cx="895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2384280" y="1871640"/>
            <a:ext cx="90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iRNA(#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>
            <a:off x="2111400" y="3079800"/>
            <a:ext cx="95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1829160" y="29415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2089080" y="2505240"/>
            <a:ext cx="95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>
            <a:off x="1806840" y="23670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5" name="" descr=""/>
          <p:cNvPicPr/>
          <p:nvPr/>
        </p:nvPicPr>
        <p:blipFill>
          <a:blip r:embed="rId2"/>
          <a:srcRect l="36940" t="28580" r="2170" b="22950"/>
          <a:stretch/>
        </p:blipFill>
        <p:spPr>
          <a:xfrm>
            <a:off x="3417840" y="2435400"/>
            <a:ext cx="1249560" cy="831600"/>
          </a:xfrm>
          <a:prstGeom prst="rect">
            <a:avLst/>
          </a:prstGeom>
          <a:ln w="0">
            <a:noFill/>
          </a:ln>
        </p:spPr>
      </p:pic>
      <p:sp>
        <p:nvSpPr>
          <p:cNvPr id="576" name=""/>
          <p:cNvSpPr/>
          <p:nvPr/>
        </p:nvSpPr>
        <p:spPr>
          <a:xfrm>
            <a:off x="3582720" y="219240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4093920" y="219240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tg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3578400" y="2149560"/>
            <a:ext cx="914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3600360" y="1868400"/>
            <a:ext cx="90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iRNA(#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"/>
          <p:cNvSpPr/>
          <p:nvPr/>
        </p:nvSpPr>
        <p:spPr>
          <a:xfrm>
            <a:off x="217440" y="709560"/>
            <a:ext cx="22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" descr=""/>
          <p:cNvPicPr/>
          <p:nvPr/>
        </p:nvPicPr>
        <p:blipFill>
          <a:blip r:embed="rId1"/>
          <a:stretch/>
        </p:blipFill>
        <p:spPr>
          <a:xfrm>
            <a:off x="254160" y="1922400"/>
            <a:ext cx="6387840" cy="1098720"/>
          </a:xfrm>
          <a:prstGeom prst="rect">
            <a:avLst/>
          </a:prstGeom>
          <a:ln w="0">
            <a:noFill/>
          </a:ln>
        </p:spPr>
      </p:pic>
      <p:sp>
        <p:nvSpPr>
          <p:cNvPr id="104" name=""/>
          <p:cNvSpPr/>
          <p:nvPr/>
        </p:nvSpPr>
        <p:spPr>
          <a:xfrm>
            <a:off x="429480" y="163368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370880" y="163368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095560" y="1638360"/>
            <a:ext cx="4508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516120" y="1252440"/>
            <a:ext cx="157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low cessation (h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398320" y="1709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337920" y="1709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4214160" y="1709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5141520" y="1709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6004440" y="17096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000080" y="4840200"/>
            <a:ext cx="214200" cy="534960"/>
          </a:xfrm>
          <a:prstGeom prst="rect">
            <a:avLst/>
          </a:prstGeom>
          <a:solidFill>
            <a:srgbClr val="0000c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000080" y="4840200"/>
            <a:ext cx="212760" cy="530280"/>
          </a:xfrm>
          <a:custGeom>
            <a:avLst/>
            <a:gdLst/>
            <a:ahLst/>
            <a:rect l="l" t="t" r="r" b="b"/>
            <a:pathLst>
              <a:path w="169" h="420">
                <a:moveTo>
                  <a:pt x="0" y="420"/>
                </a:moveTo>
                <a:lnTo>
                  <a:pt x="0" y="420"/>
                </a:lnTo>
                <a:lnTo>
                  <a:pt x="0" y="0"/>
                </a:lnTo>
                <a:lnTo>
                  <a:pt x="169" y="0"/>
                </a:lnTo>
                <a:lnTo>
                  <a:pt x="169" y="42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054080" y="4768920"/>
            <a:ext cx="10656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106640" y="4768920"/>
            <a:ext cx="0" cy="71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324080" y="4113360"/>
            <a:ext cx="214200" cy="1261800"/>
          </a:xfrm>
          <a:prstGeom prst="rect">
            <a:avLst/>
          </a:prstGeom>
          <a:solidFill>
            <a:srgbClr val="ff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324080" y="4113360"/>
            <a:ext cx="214200" cy="1257120"/>
          </a:xfrm>
          <a:custGeom>
            <a:avLst/>
            <a:gdLst/>
            <a:ahLst/>
            <a:rect l="l" t="t" r="r" b="b"/>
            <a:pathLst>
              <a:path w="169" h="996">
                <a:moveTo>
                  <a:pt x="0" y="996"/>
                </a:moveTo>
                <a:lnTo>
                  <a:pt x="0" y="996"/>
                </a:lnTo>
                <a:lnTo>
                  <a:pt x="0" y="0"/>
                </a:lnTo>
                <a:lnTo>
                  <a:pt x="169" y="0"/>
                </a:lnTo>
                <a:lnTo>
                  <a:pt x="169" y="996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378080" y="4060800"/>
            <a:ext cx="10620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432080" y="4060800"/>
            <a:ext cx="0" cy="525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649520" y="4197240"/>
            <a:ext cx="214200" cy="117792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649520" y="4197240"/>
            <a:ext cx="212760" cy="1173240"/>
          </a:xfrm>
          <a:custGeom>
            <a:avLst/>
            <a:gdLst/>
            <a:ahLst/>
            <a:rect l="l" t="t" r="r" b="b"/>
            <a:pathLst>
              <a:path w="169" h="930">
                <a:moveTo>
                  <a:pt x="0" y="930"/>
                </a:moveTo>
                <a:lnTo>
                  <a:pt x="0" y="930"/>
                </a:lnTo>
                <a:lnTo>
                  <a:pt x="0" y="0"/>
                </a:lnTo>
                <a:lnTo>
                  <a:pt x="169" y="0"/>
                </a:lnTo>
                <a:lnTo>
                  <a:pt x="169" y="93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703520" y="4164120"/>
            <a:ext cx="10620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1755720" y="4164120"/>
            <a:ext cx="0" cy="33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973160" y="4578480"/>
            <a:ext cx="216000" cy="79668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973160" y="4578480"/>
            <a:ext cx="214560" cy="792000"/>
          </a:xfrm>
          <a:custGeom>
            <a:avLst/>
            <a:gdLst/>
            <a:ahLst/>
            <a:rect l="l" t="t" r="r" b="b"/>
            <a:pathLst>
              <a:path w="169" h="627">
                <a:moveTo>
                  <a:pt x="0" y="627"/>
                </a:moveTo>
                <a:lnTo>
                  <a:pt x="0" y="627"/>
                </a:lnTo>
                <a:lnTo>
                  <a:pt x="0" y="0"/>
                </a:lnTo>
                <a:lnTo>
                  <a:pt x="169" y="0"/>
                </a:lnTo>
                <a:lnTo>
                  <a:pt x="169" y="627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028960" y="4484520"/>
            <a:ext cx="10476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081160" y="4484520"/>
            <a:ext cx="0" cy="93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298600" y="4545000"/>
            <a:ext cx="214560" cy="83016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298600" y="4545000"/>
            <a:ext cx="212760" cy="825480"/>
          </a:xfrm>
          <a:custGeom>
            <a:avLst/>
            <a:gdLst/>
            <a:ahLst/>
            <a:rect l="l" t="t" r="r" b="b"/>
            <a:pathLst>
              <a:path w="169" h="654">
                <a:moveTo>
                  <a:pt x="0" y="654"/>
                </a:moveTo>
                <a:lnTo>
                  <a:pt x="0" y="654"/>
                </a:lnTo>
                <a:lnTo>
                  <a:pt x="0" y="0"/>
                </a:lnTo>
                <a:lnTo>
                  <a:pt x="169" y="0"/>
                </a:lnTo>
                <a:lnTo>
                  <a:pt x="169" y="654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352600" y="4481640"/>
            <a:ext cx="10656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2406600" y="4481640"/>
            <a:ext cx="0" cy="63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2624040" y="4718160"/>
            <a:ext cx="214560" cy="65700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624040" y="4718160"/>
            <a:ext cx="212760" cy="652320"/>
          </a:xfrm>
          <a:custGeom>
            <a:avLst/>
            <a:gdLst/>
            <a:ahLst/>
            <a:rect l="l" t="t" r="r" b="b"/>
            <a:pathLst>
              <a:path w="169" h="517">
                <a:moveTo>
                  <a:pt x="0" y="517"/>
                </a:moveTo>
                <a:lnTo>
                  <a:pt x="0" y="517"/>
                </a:lnTo>
                <a:lnTo>
                  <a:pt x="0" y="0"/>
                </a:lnTo>
                <a:lnTo>
                  <a:pt x="169" y="0"/>
                </a:lnTo>
                <a:lnTo>
                  <a:pt x="169" y="517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2678040" y="4626000"/>
            <a:ext cx="10656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730600" y="4626000"/>
            <a:ext cx="0" cy="921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948040" y="4900680"/>
            <a:ext cx="214200" cy="47448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948040" y="4900680"/>
            <a:ext cx="214200" cy="469800"/>
          </a:xfrm>
          <a:custGeom>
            <a:avLst/>
            <a:gdLst/>
            <a:ahLst/>
            <a:rect l="l" t="t" r="r" b="b"/>
            <a:pathLst>
              <a:path w="169" h="373">
                <a:moveTo>
                  <a:pt x="0" y="373"/>
                </a:moveTo>
                <a:lnTo>
                  <a:pt x="0" y="373"/>
                </a:lnTo>
                <a:lnTo>
                  <a:pt x="0" y="0"/>
                </a:lnTo>
                <a:lnTo>
                  <a:pt x="169" y="0"/>
                </a:lnTo>
                <a:lnTo>
                  <a:pt x="169" y="373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002040" y="4786200"/>
            <a:ext cx="10620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056040" y="4786200"/>
            <a:ext cx="0" cy="114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944640" y="5375160"/>
            <a:ext cx="2274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729360" y="52704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666720" y="48402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666720" y="44100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666720" y="39672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666720" y="35244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flipV="1">
            <a:off x="946080" y="3619080"/>
            <a:ext cx="0" cy="1755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flipH="1">
            <a:off x="902880" y="537516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 flipH="1">
            <a:off x="902880" y="493380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H="1">
            <a:off x="902880" y="449280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H="1">
            <a:off x="902880" y="405432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H="1">
            <a:off x="902880" y="361332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rot="16200000">
            <a:off x="-53640" y="4460400"/>
            <a:ext cx="1040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LC3+ cells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4118040" y="5037120"/>
            <a:ext cx="222120" cy="328680"/>
          </a:xfrm>
          <a:prstGeom prst="rect">
            <a:avLst/>
          </a:prstGeom>
          <a:solidFill>
            <a:srgbClr val="0000c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4118040" y="5037120"/>
            <a:ext cx="222120" cy="322200"/>
          </a:xfrm>
          <a:custGeom>
            <a:avLst/>
            <a:gdLst/>
            <a:ahLst/>
            <a:rect l="l" t="t" r="r" b="b"/>
            <a:pathLst>
              <a:path w="169" h="246">
                <a:moveTo>
                  <a:pt x="0" y="246"/>
                </a:moveTo>
                <a:lnTo>
                  <a:pt x="0" y="246"/>
                </a:lnTo>
                <a:lnTo>
                  <a:pt x="0" y="0"/>
                </a:lnTo>
                <a:lnTo>
                  <a:pt x="169" y="0"/>
                </a:lnTo>
                <a:lnTo>
                  <a:pt x="169" y="246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175280" y="5008680"/>
            <a:ext cx="10944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4230720" y="5008680"/>
            <a:ext cx="0" cy="28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454640" y="4255920"/>
            <a:ext cx="223560" cy="1109880"/>
          </a:xfrm>
          <a:prstGeom prst="rect">
            <a:avLst/>
          </a:prstGeom>
          <a:solidFill>
            <a:srgbClr val="ff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4454640" y="4255920"/>
            <a:ext cx="222120" cy="1103400"/>
          </a:xfrm>
          <a:custGeom>
            <a:avLst/>
            <a:gdLst/>
            <a:ahLst/>
            <a:rect l="l" t="t" r="r" b="b"/>
            <a:pathLst>
              <a:path w="169" h="842">
                <a:moveTo>
                  <a:pt x="0" y="842"/>
                </a:moveTo>
                <a:lnTo>
                  <a:pt x="0" y="842"/>
                </a:lnTo>
                <a:lnTo>
                  <a:pt x="0" y="0"/>
                </a:lnTo>
                <a:lnTo>
                  <a:pt x="169" y="0"/>
                </a:lnTo>
                <a:lnTo>
                  <a:pt x="169" y="842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511520" y="4098960"/>
            <a:ext cx="10980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567320" y="4098960"/>
            <a:ext cx="0" cy="156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4792680" y="4253040"/>
            <a:ext cx="222120" cy="111276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4792680" y="4253040"/>
            <a:ext cx="220680" cy="1106280"/>
          </a:xfrm>
          <a:custGeom>
            <a:avLst/>
            <a:gdLst/>
            <a:ahLst/>
            <a:rect l="l" t="t" r="r" b="b"/>
            <a:pathLst>
              <a:path w="169" h="845">
                <a:moveTo>
                  <a:pt x="0" y="845"/>
                </a:moveTo>
                <a:lnTo>
                  <a:pt x="0" y="845"/>
                </a:lnTo>
                <a:lnTo>
                  <a:pt x="0" y="0"/>
                </a:lnTo>
                <a:lnTo>
                  <a:pt x="169" y="0"/>
                </a:lnTo>
                <a:lnTo>
                  <a:pt x="169" y="845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848120" y="4130640"/>
            <a:ext cx="111240" cy="180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4903920" y="4130640"/>
            <a:ext cx="0" cy="1224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5129280" y="4807080"/>
            <a:ext cx="222120" cy="55872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5129280" y="4807080"/>
            <a:ext cx="220680" cy="552240"/>
          </a:xfrm>
          <a:custGeom>
            <a:avLst/>
            <a:gdLst/>
            <a:ahLst/>
            <a:rect l="l" t="t" r="r" b="b"/>
            <a:pathLst>
              <a:path w="169" h="422">
                <a:moveTo>
                  <a:pt x="0" y="422"/>
                </a:moveTo>
                <a:lnTo>
                  <a:pt x="0" y="422"/>
                </a:lnTo>
                <a:lnTo>
                  <a:pt x="0" y="0"/>
                </a:lnTo>
                <a:lnTo>
                  <a:pt x="169" y="0"/>
                </a:lnTo>
                <a:lnTo>
                  <a:pt x="169" y="422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5184720" y="4727520"/>
            <a:ext cx="111240" cy="180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5240160" y="4727520"/>
            <a:ext cx="1800" cy="795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5465880" y="4824360"/>
            <a:ext cx="222120" cy="54144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5465880" y="4824360"/>
            <a:ext cx="222120" cy="534960"/>
          </a:xfrm>
          <a:custGeom>
            <a:avLst/>
            <a:gdLst/>
            <a:ahLst/>
            <a:rect l="l" t="t" r="r" b="b"/>
            <a:pathLst>
              <a:path w="169" h="408">
                <a:moveTo>
                  <a:pt x="0" y="408"/>
                </a:moveTo>
                <a:lnTo>
                  <a:pt x="0" y="408"/>
                </a:lnTo>
                <a:lnTo>
                  <a:pt x="0" y="0"/>
                </a:lnTo>
                <a:lnTo>
                  <a:pt x="169" y="0"/>
                </a:lnTo>
                <a:lnTo>
                  <a:pt x="169" y="408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5521320" y="4764240"/>
            <a:ext cx="111240" cy="144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5576760" y="4764240"/>
            <a:ext cx="1800" cy="60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5802480" y="4997520"/>
            <a:ext cx="223560" cy="36828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5802480" y="4997520"/>
            <a:ext cx="222120" cy="361800"/>
          </a:xfrm>
          <a:custGeom>
            <a:avLst/>
            <a:gdLst/>
            <a:ahLst/>
            <a:rect l="l" t="t" r="r" b="b"/>
            <a:pathLst>
              <a:path w="169" h="276">
                <a:moveTo>
                  <a:pt x="0" y="276"/>
                </a:moveTo>
                <a:lnTo>
                  <a:pt x="0" y="276"/>
                </a:lnTo>
                <a:lnTo>
                  <a:pt x="0" y="0"/>
                </a:lnTo>
                <a:lnTo>
                  <a:pt x="169" y="0"/>
                </a:lnTo>
                <a:lnTo>
                  <a:pt x="169" y="276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5859360" y="4943520"/>
            <a:ext cx="109800" cy="144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5913360" y="4943520"/>
            <a:ext cx="1800" cy="54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6138720" y="4976640"/>
            <a:ext cx="223920" cy="389160"/>
          </a:xfrm>
          <a:prstGeom prst="rect">
            <a:avLst/>
          </a:prstGeom>
          <a:solidFill>
            <a:srgbClr val="077e97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6138720" y="4976640"/>
            <a:ext cx="222480" cy="382680"/>
          </a:xfrm>
          <a:custGeom>
            <a:avLst/>
            <a:gdLst/>
            <a:ahLst/>
            <a:rect l="l" t="t" r="r" b="b"/>
            <a:pathLst>
              <a:path w="169" h="292">
                <a:moveTo>
                  <a:pt x="0" y="292"/>
                </a:moveTo>
                <a:lnTo>
                  <a:pt x="0" y="292"/>
                </a:lnTo>
                <a:lnTo>
                  <a:pt x="0" y="0"/>
                </a:lnTo>
                <a:lnTo>
                  <a:pt x="169" y="0"/>
                </a:lnTo>
                <a:lnTo>
                  <a:pt x="169" y="292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6195960" y="4896000"/>
            <a:ext cx="109440" cy="360"/>
          </a:xfrm>
          <a:custGeom>
            <a:avLst/>
            <a:gdLst/>
            <a:ahLst/>
            <a:rect l="l" t="t" r="r" b="b"/>
            <a:pathLst>
              <a:path w="84" h="0">
                <a:moveTo>
                  <a:pt x="0" y="0"/>
                </a:moveTo>
                <a:lnTo>
                  <a:pt x="84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6249960" y="4896000"/>
            <a:ext cx="1440" cy="80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3840" bIns="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4062240" y="5365800"/>
            <a:ext cx="235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flipV="1">
            <a:off x="4062240" y="3790440"/>
            <a:ext cx="0" cy="1575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flipH="1">
            <a:off x="4016160" y="5365800"/>
            <a:ext cx="45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3826800" y="5265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flipH="1">
            <a:off x="4016160" y="5049720"/>
            <a:ext cx="4572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3826800" y="49514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flipH="1">
            <a:off x="4016160" y="4735440"/>
            <a:ext cx="4572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3826800" y="46371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flipH="1">
            <a:off x="4016160" y="4421160"/>
            <a:ext cx="45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3826800" y="43210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flipH="1">
            <a:off x="4016160" y="4106880"/>
            <a:ext cx="45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3826800" y="4006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flipH="1">
            <a:off x="4016160" y="3790800"/>
            <a:ext cx="4572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3759480" y="36925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rot="16200000">
            <a:off x="2913480" y="4515120"/>
            <a:ext cx="1410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LC3 puncta per cel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1297080" y="37893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1621080" y="39099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281320" y="42400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1945080" y="42465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014200" y="420048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宋体"/>
              </a:rPr>
              <a:t>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334960" y="420696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宋体"/>
              </a:rPr>
              <a:t>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579400" y="431784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宋体"/>
              </a:rPr>
              <a:t>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900160" y="446724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宋体"/>
              </a:rPr>
              <a:t>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437360" y="38336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780080" y="38876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5125680" y="444492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宋体"/>
              </a:rPr>
              <a:t>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5474880" y="447048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宋体"/>
              </a:rPr>
              <a:t>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5757480" y="463860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宋体"/>
              </a:rPr>
              <a:t>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6087960" y="460692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  <a:ea typeface="宋体"/>
              </a:rPr>
              <a:t>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5072400" y="45036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5430960" y="45385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960120" y="54212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1300680" y="542124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1663560" y="5683320"/>
            <a:ext cx="148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1655280" y="5716440"/>
            <a:ext cx="157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low cessation (h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1613880" y="53928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1944360" y="53928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2268000" y="53928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2594880" y="53928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876760" y="53928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4090680" y="54086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4431240" y="540864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4832280" y="5670720"/>
            <a:ext cx="148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4824000" y="5703840"/>
            <a:ext cx="157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low cessation (h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4782600" y="53802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5112720" y="53802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5436720" y="53802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5763600" y="53802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6045480" y="53802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555480" y="6378480"/>
            <a:ext cx="5907240" cy="107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3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LC3 immunofluorescence images and quantitative data showing the time course of the effect of flow cessation on autophagic responses in endothelial cells. Data are mean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SEM. *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&lt; 0.05 vs static (S), 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†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&lt; 0.05 vs flow (F),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ne-way ANOVA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= 4)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204120" y="2982960"/>
            <a:ext cx="99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"/>
                <a:ea typeface="宋体"/>
              </a:rPr>
              <a:t>LC3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/</a:t>
            </a:r>
            <a:r>
              <a:rPr b="1" lang="en-US" sz="1400" spc="-1" strike="noStrike">
                <a:solidFill>
                  <a:srgbClr val="0000cc"/>
                </a:solidFill>
                <a:latin typeface="Arial"/>
                <a:ea typeface="宋体"/>
              </a:rPr>
              <a:t>DAP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3" name=""/>
          <p:cNvGrpSpPr/>
          <p:nvPr/>
        </p:nvGrpSpPr>
        <p:grpSpPr>
          <a:xfrm>
            <a:off x="2131920" y="1633680"/>
            <a:ext cx="2827440" cy="1943280"/>
            <a:chOff x="2131920" y="1633680"/>
            <a:chExt cx="2827440" cy="1943280"/>
          </a:xfrm>
        </p:grpSpPr>
        <p:sp>
          <p:nvSpPr>
            <p:cNvPr id="234" name="Rectangle 7"/>
            <p:cNvSpPr/>
            <p:nvPr/>
          </p:nvSpPr>
          <p:spPr>
            <a:xfrm>
              <a:off x="2844720" y="2951280"/>
              <a:ext cx="219240" cy="363600"/>
            </a:xfrm>
            <a:prstGeom prst="rect">
              <a:avLst/>
            </a:prstGeom>
            <a:solidFill>
              <a:srgbClr val="00999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Freeform 9"/>
            <p:cNvSpPr/>
            <p:nvPr/>
          </p:nvSpPr>
          <p:spPr>
            <a:xfrm>
              <a:off x="2874960" y="2832120"/>
              <a:ext cx="156960" cy="36360"/>
            </a:xfrm>
            <a:custGeom>
              <a:avLst/>
              <a:gdLst>
                <a:gd name="textAreaLeft" fmla="*/ 0 w 156960"/>
                <a:gd name="textAreaRight" fmla="*/ 157320 w 1569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300" h="45719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10"/>
            <p:cNvSpPr/>
            <p:nvPr/>
          </p:nvSpPr>
          <p:spPr>
            <a:xfrm>
              <a:off x="2954160" y="2832120"/>
              <a:ext cx="0" cy="119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11"/>
            <p:cNvSpPr/>
            <p:nvPr/>
          </p:nvSpPr>
          <p:spPr>
            <a:xfrm>
              <a:off x="3287520" y="2239920"/>
              <a:ext cx="231840" cy="1074960"/>
            </a:xfrm>
            <a:prstGeom prst="rect">
              <a:avLst/>
            </a:prstGeom>
            <a:solidFill>
              <a:srgbClr val="ff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Freeform 13"/>
            <p:cNvSpPr/>
            <p:nvPr/>
          </p:nvSpPr>
          <p:spPr>
            <a:xfrm>
              <a:off x="3324240" y="2071800"/>
              <a:ext cx="156960" cy="36360"/>
            </a:xfrm>
            <a:custGeom>
              <a:avLst/>
              <a:gdLst>
                <a:gd name="textAreaLeft" fmla="*/ 0 w 156960"/>
                <a:gd name="textAreaRight" fmla="*/ 157320 w 1569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300" h="45719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14"/>
            <p:cNvSpPr/>
            <p:nvPr/>
          </p:nvSpPr>
          <p:spPr>
            <a:xfrm>
              <a:off x="3402000" y="2071800"/>
              <a:ext cx="1440" cy="168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23"/>
            <p:cNvSpPr/>
            <p:nvPr/>
          </p:nvSpPr>
          <p:spPr>
            <a:xfrm>
              <a:off x="2466000" y="32209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27"/>
            <p:cNvSpPr/>
            <p:nvPr/>
          </p:nvSpPr>
          <p:spPr>
            <a:xfrm>
              <a:off x="2381400" y="22608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1"/>
            <p:cNvSpPr/>
            <p:nvPr/>
          </p:nvSpPr>
          <p:spPr>
            <a:xfrm flipV="1">
              <a:off x="2643120" y="1874880"/>
              <a:ext cx="0" cy="1440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22"/>
            <p:cNvSpPr/>
            <p:nvPr/>
          </p:nvSpPr>
          <p:spPr>
            <a:xfrm flipH="1">
              <a:off x="2574720" y="3314880"/>
              <a:ext cx="684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24"/>
            <p:cNvSpPr/>
            <p:nvPr/>
          </p:nvSpPr>
          <p:spPr>
            <a:xfrm flipH="1">
              <a:off x="2574720" y="2835360"/>
              <a:ext cx="68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25"/>
            <p:cNvSpPr/>
            <p:nvPr/>
          </p:nvSpPr>
          <p:spPr>
            <a:xfrm>
              <a:off x="2466000" y="27385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26"/>
            <p:cNvSpPr/>
            <p:nvPr/>
          </p:nvSpPr>
          <p:spPr>
            <a:xfrm flipH="1">
              <a:off x="2574720" y="2355840"/>
              <a:ext cx="684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28"/>
            <p:cNvSpPr/>
            <p:nvPr/>
          </p:nvSpPr>
          <p:spPr>
            <a:xfrm flipH="1">
              <a:off x="2574720" y="1874880"/>
              <a:ext cx="684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29"/>
            <p:cNvSpPr/>
            <p:nvPr/>
          </p:nvSpPr>
          <p:spPr>
            <a:xfrm>
              <a:off x="2381400" y="17780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18"/>
            <p:cNvSpPr/>
            <p:nvPr/>
          </p:nvSpPr>
          <p:spPr>
            <a:xfrm>
              <a:off x="2726280" y="3394080"/>
              <a:ext cx="41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tati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20"/>
            <p:cNvSpPr/>
            <p:nvPr/>
          </p:nvSpPr>
          <p:spPr>
            <a:xfrm>
              <a:off x="3318120" y="3394080"/>
              <a:ext cx="186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57"/>
            <p:cNvSpPr/>
            <p:nvPr/>
          </p:nvSpPr>
          <p:spPr>
            <a:xfrm rot="16200000">
              <a:off x="1451880" y="2504160"/>
              <a:ext cx="1542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C3 p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uncta per cell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4381560" y="3362400"/>
              <a:ext cx="212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O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3791520" y="3381480"/>
              <a:ext cx="398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ow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11"/>
            <p:cNvSpPr/>
            <p:nvPr/>
          </p:nvSpPr>
          <p:spPr>
            <a:xfrm>
              <a:off x="3855960" y="2789280"/>
              <a:ext cx="231840" cy="522360"/>
            </a:xfrm>
            <a:prstGeom prst="rect">
              <a:avLst/>
            </a:prstGeom>
            <a:solidFill>
              <a:srgbClr val="ff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Rectangle 11"/>
            <p:cNvSpPr/>
            <p:nvPr/>
          </p:nvSpPr>
          <p:spPr>
            <a:xfrm>
              <a:off x="4357440" y="2714760"/>
              <a:ext cx="231840" cy="598320"/>
            </a:xfrm>
            <a:prstGeom prst="rect">
              <a:avLst/>
            </a:prstGeom>
            <a:solidFill>
              <a:srgbClr val="ff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606760" y="3314880"/>
              <a:ext cx="2352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Freeform 13"/>
            <p:cNvSpPr/>
            <p:nvPr/>
          </p:nvSpPr>
          <p:spPr>
            <a:xfrm>
              <a:off x="3887640" y="2687760"/>
              <a:ext cx="157320" cy="36360"/>
            </a:xfrm>
            <a:custGeom>
              <a:avLst/>
              <a:gdLst>
                <a:gd name="textAreaLeft" fmla="*/ 0 w 157320"/>
                <a:gd name="textAreaRight" fmla="*/ 157680 w 1573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300" h="45719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14"/>
            <p:cNvSpPr/>
            <p:nvPr/>
          </p:nvSpPr>
          <p:spPr>
            <a:xfrm>
              <a:off x="3967200" y="2687760"/>
              <a:ext cx="0" cy="101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Freeform 13"/>
            <p:cNvSpPr/>
            <p:nvPr/>
          </p:nvSpPr>
          <p:spPr>
            <a:xfrm>
              <a:off x="4389480" y="2656080"/>
              <a:ext cx="156960" cy="36360"/>
            </a:xfrm>
            <a:custGeom>
              <a:avLst/>
              <a:gdLst>
                <a:gd name="textAreaLeft" fmla="*/ 0 w 156960"/>
                <a:gd name="textAreaRight" fmla="*/ 157320 w 1569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300" h="45719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14"/>
            <p:cNvSpPr/>
            <p:nvPr/>
          </p:nvSpPr>
          <p:spPr>
            <a:xfrm>
              <a:off x="4467240" y="2660760"/>
              <a:ext cx="1440" cy="58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3000240" y="1644840"/>
              <a:ext cx="2797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2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3773160" y="1633680"/>
              <a:ext cx="2797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2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 flipV="1">
              <a:off x="2944800" y="1893960"/>
              <a:ext cx="0" cy="9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944800" y="1889280"/>
              <a:ext cx="415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3360600" y="1898640"/>
              <a:ext cx="0" cy="120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3421080" y="1892160"/>
              <a:ext cx="0" cy="12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3421080" y="1889280"/>
              <a:ext cx="1025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4446360" y="1889280"/>
              <a:ext cx="0" cy="711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3959280" y="1889280"/>
              <a:ext cx="0" cy="71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0" name=""/>
          <p:cNvSpPr/>
          <p:nvPr/>
        </p:nvSpPr>
        <p:spPr>
          <a:xfrm>
            <a:off x="593640" y="4035600"/>
            <a:ext cx="5907240" cy="107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3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ffects of different types of flow on autophagy in endothelial cells detected by LC3 immunofluorescence. LF, laminar flow (12 dyn/cm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); LowF, low magnitude flow (4 dyn/cm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); OF, oscillatory flow (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5 dyn/cm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at 1 Hz). Data are mean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SEM. *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&lt; 0.05, one-way ANOVA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= 4)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455040" y="744480"/>
            <a:ext cx="232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I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"/>
          <p:cNvSpPr/>
          <p:nvPr/>
        </p:nvSpPr>
        <p:spPr>
          <a:xfrm>
            <a:off x="332640" y="797040"/>
            <a:ext cx="234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I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544680" y="6523200"/>
            <a:ext cx="5906880" cy="107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3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ffects of chloroquine (5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) on autophagic flux in static endothelial cells detected by LC3 immunofluorescence (red). DMSO was used as vehicle control. Cells were counterstained with DAPI (blue). *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&lt; 0.05, unpaired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test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= 3)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2751120" y="5232240"/>
            <a:ext cx="619200" cy="327240"/>
          </a:xfrm>
          <a:custGeom>
            <a:avLst/>
            <a:gdLst/>
            <a:ahLst/>
            <a:rect l="l" t="t" r="r" b="b"/>
            <a:pathLst>
              <a:path w="599" h="236">
                <a:moveTo>
                  <a:pt x="0" y="236"/>
                </a:moveTo>
                <a:lnTo>
                  <a:pt x="0" y="236"/>
                </a:lnTo>
                <a:lnTo>
                  <a:pt x="0" y="0"/>
                </a:lnTo>
                <a:lnTo>
                  <a:pt x="599" y="0"/>
                </a:lnTo>
                <a:lnTo>
                  <a:pt x="599" y="236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3679920" y="4425840"/>
            <a:ext cx="619200" cy="1138320"/>
          </a:xfrm>
          <a:prstGeom prst="rect">
            <a:avLst/>
          </a:prstGeom>
          <a:solidFill>
            <a:srgbClr val="60606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3833640" y="4162320"/>
            <a:ext cx="31140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3989520" y="4162320"/>
            <a:ext cx="0" cy="263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2597040" y="5564160"/>
            <a:ext cx="185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2887200" y="5700600"/>
            <a:ext cx="34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3484080" y="5700600"/>
            <a:ext cx="1047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hloroqui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 flipV="1">
            <a:off x="2597040" y="3903840"/>
            <a:ext cx="0" cy="1660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 flipH="1">
            <a:off x="2561760" y="556416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2402640" y="54896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 flipH="1">
            <a:off x="2561760" y="523224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2402640" y="5157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 flipH="1">
            <a:off x="2561760" y="490068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2402640" y="48243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 flipH="1">
            <a:off x="2561760" y="456876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2402640" y="4494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 flipH="1">
            <a:off x="2561760" y="423720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2402640" y="41623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 flipH="1">
            <a:off x="2561760" y="390384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2402640" y="38307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 rot="16200000">
            <a:off x="1244880" y="4559040"/>
            <a:ext cx="16160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Relative fluorescenc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intensity (fol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3830040" y="387036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Tahoma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6" name="" descr=""/>
          <p:cNvPicPr/>
          <p:nvPr/>
        </p:nvPicPr>
        <p:blipFill>
          <a:blip r:embed="rId1"/>
          <a:stretch/>
        </p:blipFill>
        <p:spPr>
          <a:xfrm>
            <a:off x="1187280" y="1711440"/>
            <a:ext cx="4499280" cy="1817640"/>
          </a:xfrm>
          <a:prstGeom prst="rect">
            <a:avLst/>
          </a:prstGeom>
          <a:ln w="0">
            <a:noFill/>
          </a:ln>
        </p:spPr>
      </p:pic>
      <p:sp>
        <p:nvSpPr>
          <p:cNvPr id="297" name=""/>
          <p:cNvSpPr/>
          <p:nvPr/>
        </p:nvSpPr>
        <p:spPr>
          <a:xfrm>
            <a:off x="2198160" y="1440000"/>
            <a:ext cx="34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4014360" y="1440000"/>
            <a:ext cx="1047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hloroqui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 flipV="1">
            <a:off x="3057480" y="5076720"/>
            <a:ext cx="0" cy="152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2897280" y="5073480"/>
            <a:ext cx="311040" cy="360"/>
          </a:xfrm>
          <a:custGeom>
            <a:avLst/>
            <a:gdLst/>
            <a:ahLst/>
            <a:rect l="l" t="t" r="r" b="b"/>
            <a:pathLst>
              <a:path w="300" h="0">
                <a:moveTo>
                  <a:pt x="0" y="0"/>
                </a:moveTo>
                <a:lnTo>
                  <a:pt x="30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1" name="" descr=""/>
          <p:cNvPicPr/>
          <p:nvPr/>
        </p:nvPicPr>
        <p:blipFill>
          <a:blip r:embed="rId1"/>
          <a:stretch/>
        </p:blipFill>
        <p:spPr>
          <a:xfrm>
            <a:off x="1278000" y="1486080"/>
            <a:ext cx="4199040" cy="3695400"/>
          </a:xfrm>
          <a:prstGeom prst="rect">
            <a:avLst/>
          </a:prstGeom>
          <a:ln w="0">
            <a:noFill/>
          </a:ln>
        </p:spPr>
      </p:pic>
      <p:sp>
        <p:nvSpPr>
          <p:cNvPr id="302" name=""/>
          <p:cNvSpPr/>
          <p:nvPr/>
        </p:nvSpPr>
        <p:spPr>
          <a:xfrm>
            <a:off x="333000" y="797040"/>
            <a:ext cx="2289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458640" y="7980480"/>
            <a:ext cx="5907240" cy="83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3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ffects of laminar flow on LC3 puncta accumulation in the absence and presence of bafilomycin A1 (10 nM) pretreatment. Cells were counterstained with DAPI (blue). *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&lt; 0.05, one-way ANOVA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= 4)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2970360" y="6854760"/>
            <a:ext cx="318960" cy="1303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2970360" y="6854760"/>
            <a:ext cx="317520" cy="125640"/>
          </a:xfrm>
          <a:custGeom>
            <a:avLst/>
            <a:gdLst/>
            <a:ahLst/>
            <a:rect l="l" t="t" r="r" b="b"/>
            <a:pathLst>
              <a:path w="299" h="116">
                <a:moveTo>
                  <a:pt x="0" y="116"/>
                </a:moveTo>
                <a:lnTo>
                  <a:pt x="0" y="116"/>
                </a:lnTo>
                <a:lnTo>
                  <a:pt x="0" y="0"/>
                </a:lnTo>
                <a:lnTo>
                  <a:pt x="299" y="0"/>
                </a:lnTo>
                <a:lnTo>
                  <a:pt x="299" y="116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3497400" y="6446880"/>
            <a:ext cx="318960" cy="538200"/>
          </a:xfrm>
          <a:prstGeom prst="rect">
            <a:avLst/>
          </a:prstGeom>
          <a:solidFill>
            <a:srgbClr val="60606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3497400" y="6446880"/>
            <a:ext cx="317520" cy="533520"/>
          </a:xfrm>
          <a:custGeom>
            <a:avLst/>
            <a:gdLst/>
            <a:ahLst/>
            <a:rect l="l" t="t" r="r" b="b"/>
            <a:pathLst>
              <a:path w="299" h="498">
                <a:moveTo>
                  <a:pt x="0" y="498"/>
                </a:moveTo>
                <a:lnTo>
                  <a:pt x="0" y="498"/>
                </a:lnTo>
                <a:lnTo>
                  <a:pt x="0" y="0"/>
                </a:lnTo>
                <a:lnTo>
                  <a:pt x="299" y="0"/>
                </a:lnTo>
                <a:lnTo>
                  <a:pt x="299" y="498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3576600" y="6386400"/>
            <a:ext cx="16020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3657600" y="6386400"/>
            <a:ext cx="0" cy="60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4051440" y="6550200"/>
            <a:ext cx="318960" cy="434880"/>
          </a:xfrm>
          <a:prstGeom prst="rect">
            <a:avLst/>
          </a:prstGeom>
          <a:solidFill>
            <a:srgbClr val="60606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4051440" y="6550200"/>
            <a:ext cx="318960" cy="430200"/>
          </a:xfrm>
          <a:custGeom>
            <a:avLst/>
            <a:gdLst/>
            <a:ahLst/>
            <a:rect l="l" t="t" r="r" b="b"/>
            <a:pathLst>
              <a:path w="299" h="402">
                <a:moveTo>
                  <a:pt x="0" y="402"/>
                </a:moveTo>
                <a:lnTo>
                  <a:pt x="0" y="402"/>
                </a:lnTo>
                <a:lnTo>
                  <a:pt x="0" y="0"/>
                </a:lnTo>
                <a:lnTo>
                  <a:pt x="299" y="0"/>
                </a:lnTo>
                <a:lnTo>
                  <a:pt x="299" y="402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4130640" y="6519960"/>
            <a:ext cx="16020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4211640" y="6519960"/>
            <a:ext cx="0" cy="30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4606920" y="5956200"/>
            <a:ext cx="318960" cy="1028880"/>
          </a:xfrm>
          <a:prstGeom prst="rect">
            <a:avLst/>
          </a:prstGeom>
          <a:solidFill>
            <a:srgbClr val="60606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4606920" y="5956200"/>
            <a:ext cx="317520" cy="1024200"/>
          </a:xfrm>
          <a:custGeom>
            <a:avLst/>
            <a:gdLst/>
            <a:ahLst/>
            <a:rect l="l" t="t" r="r" b="b"/>
            <a:pathLst>
              <a:path w="299" h="957">
                <a:moveTo>
                  <a:pt x="0" y="957"/>
                </a:moveTo>
                <a:lnTo>
                  <a:pt x="0" y="957"/>
                </a:lnTo>
                <a:lnTo>
                  <a:pt x="0" y="0"/>
                </a:lnTo>
                <a:lnTo>
                  <a:pt x="299" y="0"/>
                </a:lnTo>
                <a:lnTo>
                  <a:pt x="299" y="957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4686480" y="5824440"/>
            <a:ext cx="15840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4765680" y="5824440"/>
            <a:ext cx="0" cy="131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2690640" y="6985080"/>
            <a:ext cx="2400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2927880" y="7053120"/>
            <a:ext cx="41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3465360" y="7053120"/>
            <a:ext cx="425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hea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V="1">
            <a:off x="2690640" y="5700600"/>
            <a:ext cx="0" cy="1284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 flipH="1">
            <a:off x="2655360" y="698508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2490120" y="68976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 flipH="1">
            <a:off x="2655360" y="672768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2490120" y="66405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 flipH="1">
            <a:off x="2655360" y="647064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2490120" y="63849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 flipH="1">
            <a:off x="2655360" y="621360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2490120" y="61279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 flipH="1">
            <a:off x="2655360" y="595800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2490120" y="5870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 flipH="1">
            <a:off x="2655360" y="570060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2433960" y="56149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 rot="16200000">
            <a:off x="1330560" y="6159240"/>
            <a:ext cx="16160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Relative fluorescenc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intensity (fol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3526200" y="60991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4631040" y="55656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4078440" y="62611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4014720" y="7448400"/>
            <a:ext cx="1052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+ bafilomyc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4020120" y="7053120"/>
            <a:ext cx="41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4557600" y="7053120"/>
            <a:ext cx="425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hea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3971880" y="7343640"/>
            <a:ext cx="1066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3043080" y="6780240"/>
            <a:ext cx="160560" cy="36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124080" y="6780240"/>
            <a:ext cx="0" cy="73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3657600" y="5562720"/>
            <a:ext cx="1123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4084920" y="53150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"/>
          <p:cNvSpPr/>
          <p:nvPr/>
        </p:nvSpPr>
        <p:spPr>
          <a:xfrm>
            <a:off x="3344760" y="5573880"/>
            <a:ext cx="239760" cy="477720"/>
          </a:xfrm>
          <a:custGeom>
            <a:avLst/>
            <a:gdLst/>
            <a:ahLst/>
            <a:rect l="l" t="t" r="r" b="b"/>
            <a:pathLst>
              <a:path w="223" h="396">
                <a:moveTo>
                  <a:pt x="0" y="396"/>
                </a:moveTo>
                <a:lnTo>
                  <a:pt x="0" y="396"/>
                </a:lnTo>
                <a:lnTo>
                  <a:pt x="0" y="0"/>
                </a:lnTo>
                <a:lnTo>
                  <a:pt x="223" y="0"/>
                </a:lnTo>
                <a:lnTo>
                  <a:pt x="223" y="396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3936960" y="4851360"/>
            <a:ext cx="241200" cy="1204920"/>
          </a:xfrm>
          <a:prstGeom prst="rect">
            <a:avLst/>
          </a:prstGeom>
          <a:solidFill>
            <a:srgbClr val="60606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3997440" y="4761000"/>
            <a:ext cx="120600" cy="360"/>
          </a:xfrm>
          <a:custGeom>
            <a:avLst/>
            <a:gdLst/>
            <a:ahLst/>
            <a:rect l="l" t="t" r="r" b="b"/>
            <a:pathLst>
              <a:path w="112" h="0">
                <a:moveTo>
                  <a:pt x="0" y="0"/>
                </a:moveTo>
                <a:lnTo>
                  <a:pt x="112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4057560" y="4761000"/>
            <a:ext cx="0" cy="90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3021120" y="6056280"/>
            <a:ext cx="1454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3246840" y="6100920"/>
            <a:ext cx="41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3900960" y="6100920"/>
            <a:ext cx="348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 flipV="1">
            <a:off x="3021120" y="4609800"/>
            <a:ext cx="0" cy="1446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 flipH="1">
            <a:off x="2984400" y="6056280"/>
            <a:ext cx="36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2831400" y="5962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 flipH="1">
            <a:off x="2984400" y="5573880"/>
            <a:ext cx="36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2831400" y="54799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 flipH="1">
            <a:off x="2984400" y="5091120"/>
            <a:ext cx="36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2831400" y="49989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 flipH="1">
            <a:off x="2984400" y="4610160"/>
            <a:ext cx="36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2831400" y="45165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 rot="16200000">
            <a:off x="1804320" y="5237280"/>
            <a:ext cx="1587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Relative density (fol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3625560" y="429408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20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546120" y="6546960"/>
            <a:ext cx="6013440" cy="77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Densitometry data of western blot experiments showing the effects of laminar flow (20 dyn/cm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) on (A) phosphorylation of mTOR and ULK1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= 4) and (B) the protein level of Sirt1 in HUVECs. *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&lt; 0.05,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test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= 4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2206800" y="2368440"/>
            <a:ext cx="399960" cy="1270080"/>
          </a:xfrm>
          <a:custGeom>
            <a:avLst/>
            <a:gdLst/>
            <a:ahLst/>
            <a:rect l="l" t="t" r="r" b="b"/>
            <a:pathLst>
              <a:path w="299" h="800">
                <a:moveTo>
                  <a:pt x="0" y="800"/>
                </a:moveTo>
                <a:lnTo>
                  <a:pt x="0" y="800"/>
                </a:lnTo>
                <a:lnTo>
                  <a:pt x="0" y="0"/>
                </a:lnTo>
                <a:lnTo>
                  <a:pt x="299" y="0"/>
                </a:lnTo>
                <a:lnTo>
                  <a:pt x="299" y="800"/>
                </a:lnTo>
              </a:path>
            </a:pathLst>
          </a:custGeom>
          <a:solidFill>
            <a:srgbClr val="808080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2809800" y="2530440"/>
            <a:ext cx="399960" cy="1108080"/>
          </a:xfrm>
          <a:custGeom>
            <a:avLst/>
            <a:gdLst/>
            <a:ahLst/>
            <a:rect l="l" t="t" r="r" b="b"/>
            <a:pathLst>
              <a:path w="299" h="746">
                <a:moveTo>
                  <a:pt x="0" y="746"/>
                </a:moveTo>
                <a:lnTo>
                  <a:pt x="0" y="746"/>
                </a:lnTo>
                <a:lnTo>
                  <a:pt x="0" y="0"/>
                </a:lnTo>
                <a:lnTo>
                  <a:pt x="299" y="0"/>
                </a:lnTo>
                <a:lnTo>
                  <a:pt x="299" y="746"/>
                </a:lnTo>
              </a:path>
            </a:pathLst>
          </a:custGeom>
          <a:solidFill>
            <a:srgbClr val="808080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2909880" y="2365200"/>
            <a:ext cx="200160" cy="180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3009960" y="2365200"/>
            <a:ext cx="1440" cy="165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2489760" y="1496880"/>
            <a:ext cx="4212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mTO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4607640" y="1468440"/>
            <a:ext cx="365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ULK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 flipV="1">
            <a:off x="2058840" y="1733400"/>
            <a:ext cx="1800" cy="1905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 flipH="1">
            <a:off x="2003400" y="363852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1845360" y="35528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 flipH="1">
            <a:off x="2003400" y="300348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1717920" y="29178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 flipH="1">
            <a:off x="2003400" y="236844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1717920" y="22827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 flipH="1">
            <a:off x="2003400" y="173340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1717920" y="1647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2058840" y="3638520"/>
            <a:ext cx="1266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4284720" y="2365200"/>
            <a:ext cx="399960" cy="1270080"/>
          </a:xfrm>
          <a:custGeom>
            <a:avLst/>
            <a:gdLst/>
            <a:ahLst/>
            <a:rect l="l" t="t" r="r" b="b"/>
            <a:pathLst>
              <a:path w="299" h="800">
                <a:moveTo>
                  <a:pt x="0" y="800"/>
                </a:moveTo>
                <a:lnTo>
                  <a:pt x="0" y="800"/>
                </a:lnTo>
                <a:lnTo>
                  <a:pt x="0" y="0"/>
                </a:lnTo>
                <a:lnTo>
                  <a:pt x="299" y="0"/>
                </a:lnTo>
                <a:lnTo>
                  <a:pt x="299" y="800"/>
                </a:lnTo>
              </a:path>
            </a:pathLst>
          </a:custGeom>
          <a:solidFill>
            <a:srgbClr val="808080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4888080" y="2271600"/>
            <a:ext cx="399960" cy="1363680"/>
          </a:xfrm>
          <a:custGeom>
            <a:avLst/>
            <a:gdLst/>
            <a:ahLst/>
            <a:rect l="l" t="t" r="r" b="b"/>
            <a:pathLst>
              <a:path w="299" h="919">
                <a:moveTo>
                  <a:pt x="0" y="919"/>
                </a:moveTo>
                <a:lnTo>
                  <a:pt x="0" y="919"/>
                </a:lnTo>
                <a:lnTo>
                  <a:pt x="0" y="0"/>
                </a:lnTo>
                <a:lnTo>
                  <a:pt x="299" y="0"/>
                </a:lnTo>
                <a:lnTo>
                  <a:pt x="299" y="919"/>
                </a:lnTo>
              </a:path>
            </a:pathLst>
          </a:custGeom>
          <a:solidFill>
            <a:srgbClr val="808080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4987800" y="2044800"/>
            <a:ext cx="200160" cy="144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5087880" y="2044800"/>
            <a:ext cx="1800" cy="217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 flipV="1">
            <a:off x="4122720" y="1730160"/>
            <a:ext cx="1440" cy="1904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 flipH="1">
            <a:off x="4067280" y="363528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3909240" y="35496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 flipH="1">
            <a:off x="4067280" y="300024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3781440" y="29145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 flipH="1">
            <a:off x="4067280" y="236520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3781440" y="2279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 flipH="1">
            <a:off x="4067280" y="173052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3781440" y="16444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4122720" y="3635280"/>
            <a:ext cx="1324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 rot="16200000">
            <a:off x="506880" y="2559240"/>
            <a:ext cx="199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hospho/total ratio (fol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2107440" y="367200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2766240" y="367200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4170960" y="367200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4830120" y="367200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661320" y="125424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(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1544040" y="435600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(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303480" y="825480"/>
            <a:ext cx="2390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V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 flipV="1">
            <a:off x="3448080" y="4529160"/>
            <a:ext cx="0" cy="752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3457440" y="4529160"/>
            <a:ext cx="59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4057560" y="4529160"/>
            <a:ext cx="0" cy="171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2306520" y="2000160"/>
            <a:ext cx="200160" cy="180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2406600" y="2000160"/>
            <a:ext cx="1800" cy="355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4375080" y="2079720"/>
            <a:ext cx="200160" cy="144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4475160" y="2079720"/>
            <a:ext cx="1440" cy="293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3394080" y="5408640"/>
            <a:ext cx="120600" cy="360"/>
          </a:xfrm>
          <a:custGeom>
            <a:avLst/>
            <a:gdLst/>
            <a:ahLst/>
            <a:rect l="l" t="t" r="r" b="b"/>
            <a:pathLst>
              <a:path w="112" h="0">
                <a:moveTo>
                  <a:pt x="0" y="0"/>
                </a:moveTo>
                <a:lnTo>
                  <a:pt x="112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3460680" y="5408640"/>
            <a:ext cx="0" cy="160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2" name="" descr=""/>
          <p:cNvPicPr/>
          <p:nvPr/>
        </p:nvPicPr>
        <p:blipFill>
          <a:blip r:embed="rId1"/>
          <a:stretch/>
        </p:blipFill>
        <p:spPr>
          <a:xfrm>
            <a:off x="1657440" y="1471680"/>
            <a:ext cx="3543120" cy="1812960"/>
          </a:xfrm>
          <a:prstGeom prst="rect">
            <a:avLst/>
          </a:prstGeom>
          <a:ln w="0">
            <a:noFill/>
          </a:ln>
        </p:spPr>
      </p:pic>
      <p:sp>
        <p:nvSpPr>
          <p:cNvPr id="413" name=""/>
          <p:cNvSpPr/>
          <p:nvPr/>
        </p:nvSpPr>
        <p:spPr>
          <a:xfrm>
            <a:off x="2265480" y="3247920"/>
            <a:ext cx="66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tati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4062960" y="3247920"/>
            <a:ext cx="5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Flo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816120" y="3898800"/>
            <a:ext cx="5654520" cy="54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Images of DCFH-DA fluorescence (green) showing that flow stimulation increased intracellular ROS productio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302760" y="825480"/>
            <a:ext cx="244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VI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"/>
          <p:cNvSpPr/>
          <p:nvPr/>
        </p:nvSpPr>
        <p:spPr>
          <a:xfrm>
            <a:off x="421200" y="534960"/>
            <a:ext cx="2491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VII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2352600" y="1962000"/>
            <a:ext cx="474840" cy="1905120"/>
          </a:xfrm>
          <a:custGeom>
            <a:avLst/>
            <a:gdLst/>
            <a:ahLst/>
            <a:rect l="l" t="t" r="r" b="b"/>
            <a:pathLst>
              <a:path w="299" h="1200">
                <a:moveTo>
                  <a:pt x="0" y="1200"/>
                </a:moveTo>
                <a:lnTo>
                  <a:pt x="0" y="1200"/>
                </a:lnTo>
                <a:lnTo>
                  <a:pt x="0" y="0"/>
                </a:lnTo>
                <a:lnTo>
                  <a:pt x="299" y="0"/>
                </a:lnTo>
                <a:lnTo>
                  <a:pt x="299" y="1200"/>
                </a:lnTo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2952720" y="3084480"/>
            <a:ext cx="474840" cy="782640"/>
          </a:xfrm>
          <a:custGeom>
            <a:avLst/>
            <a:gdLst/>
            <a:ahLst/>
            <a:rect l="l" t="t" r="r" b="b"/>
            <a:pathLst>
              <a:path w="299" h="823">
                <a:moveTo>
                  <a:pt x="0" y="823"/>
                </a:moveTo>
                <a:lnTo>
                  <a:pt x="0" y="823"/>
                </a:lnTo>
                <a:lnTo>
                  <a:pt x="0" y="0"/>
                </a:lnTo>
                <a:lnTo>
                  <a:pt x="299" y="0"/>
                </a:lnTo>
                <a:lnTo>
                  <a:pt x="299" y="823"/>
                </a:lnTo>
              </a:path>
            </a:pathLst>
          </a:custGeom>
          <a:solidFill>
            <a:srgbClr val="808080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3071880" y="2624040"/>
            <a:ext cx="237960" cy="180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 flipV="1">
            <a:off x="2147760" y="1440000"/>
            <a:ext cx="1800" cy="2427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 flipH="1">
            <a:off x="2092320" y="386712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1958040" y="3767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 flipH="1">
            <a:off x="2092320" y="348624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1830600" y="3386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 flipH="1">
            <a:off x="2092320" y="310500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1830600" y="30052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 flipH="1">
            <a:off x="2092320" y="272412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1830600" y="26240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 flipH="1">
            <a:off x="2092320" y="234324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1830600" y="2243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 flipH="1">
            <a:off x="2092320" y="196200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1830600" y="18622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2427120" y="5183280"/>
            <a:ext cx="476280" cy="1904760"/>
          </a:xfrm>
          <a:prstGeom prst="rect">
            <a:avLst/>
          </a:prstGeom>
          <a:solidFill>
            <a:srgbClr val="a0a0a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3255840" y="6072120"/>
            <a:ext cx="476280" cy="1015920"/>
          </a:xfrm>
          <a:prstGeom prst="rect">
            <a:avLst/>
          </a:prstGeom>
          <a:solidFill>
            <a:srgbClr val="a0a0a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4094280" y="5756400"/>
            <a:ext cx="476280" cy="1331640"/>
          </a:xfrm>
          <a:prstGeom prst="rect">
            <a:avLst/>
          </a:prstGeom>
          <a:solidFill>
            <a:srgbClr val="a0a0a4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 flipV="1">
            <a:off x="2089080" y="5182920"/>
            <a:ext cx="1800" cy="1904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 flipH="1">
            <a:off x="2033640" y="708804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1913760" y="70023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 flipH="1">
            <a:off x="2033640" y="670716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1785960" y="66214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 flipH="1">
            <a:off x="2033640" y="632628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1785960" y="62406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 flipH="1">
            <a:off x="2033640" y="5945040"/>
            <a:ext cx="554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1785960" y="58593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 flipH="1">
            <a:off x="2033640" y="556416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1785960" y="54784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 flipH="1">
            <a:off x="2033640" y="5183280"/>
            <a:ext cx="554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1785960" y="50976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3801960" y="1959120"/>
            <a:ext cx="476280" cy="1904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4402080" y="1757520"/>
            <a:ext cx="474840" cy="2106360"/>
          </a:xfrm>
          <a:custGeom>
            <a:avLst/>
            <a:gdLst/>
            <a:ahLst/>
            <a:rect l="l" t="t" r="r" b="b"/>
            <a:pathLst>
              <a:path w="299" h="823">
                <a:moveTo>
                  <a:pt x="0" y="823"/>
                </a:moveTo>
                <a:lnTo>
                  <a:pt x="0" y="823"/>
                </a:lnTo>
                <a:lnTo>
                  <a:pt x="0" y="0"/>
                </a:lnTo>
                <a:lnTo>
                  <a:pt x="299" y="0"/>
                </a:lnTo>
                <a:lnTo>
                  <a:pt x="299" y="823"/>
                </a:lnTo>
              </a:path>
            </a:pathLst>
          </a:custGeom>
          <a:solidFill>
            <a:srgbClr val="808080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2147760" y="3867120"/>
            <a:ext cx="28576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3043080" y="222084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20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4452840" y="129060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 rot="16200000">
            <a:off x="452520" y="2594880"/>
            <a:ext cx="231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cetyl/total FoxO1 ratio (fol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853560" y="1098720"/>
            <a:ext cx="46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926640" y="4619520"/>
            <a:ext cx="46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2285280" y="388764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2928240" y="388764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2352600" y="4206960"/>
            <a:ext cx="1060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3748680" y="388476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at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4372920" y="388476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3787920" y="4206960"/>
            <a:ext cx="1079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2480400" y="4259160"/>
            <a:ext cx="86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- Ex-5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3868200" y="4259160"/>
            <a:ext cx="909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+ Ex-5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 rot="16200000">
            <a:off x="457200" y="5925600"/>
            <a:ext cx="231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cetyl/total FoxO1 ratio (fol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2426400" y="7161120"/>
            <a:ext cx="4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3265920" y="716112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R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4107600" y="7157880"/>
            <a:ext cx="5065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2089080" y="7088040"/>
            <a:ext cx="285768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573120" y="7688160"/>
            <a:ext cx="5892840" cy="103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estern blot densitometry data showing (A) the effects of laminar flow on the level of FoxO1 acetylation in the absence and presence of EX-527 (1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) cotreatment; and (B) the effects of resveratrol (Res) (1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) and 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(30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) on the level of FoxO1 acetylation. Data are mean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SEM. *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&lt; 0.05 versus control, one-way ANOVA (n = 3). NS, non-significan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3375000" y="5846760"/>
            <a:ext cx="238320" cy="144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3494160" y="5846760"/>
            <a:ext cx="4680" cy="216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3344760" y="556092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20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4198680" y="534816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20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4216320" y="5621400"/>
            <a:ext cx="238320" cy="144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 flipH="1">
            <a:off x="4334040" y="5621400"/>
            <a:ext cx="1440" cy="136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4514760" y="1585800"/>
            <a:ext cx="238320" cy="180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4633920" y="1585800"/>
            <a:ext cx="3240" cy="168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3191040" y="2629080"/>
            <a:ext cx="0" cy="457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2459160" y="1801800"/>
            <a:ext cx="237960" cy="144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2577960" y="1797120"/>
            <a:ext cx="0" cy="171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3922560" y="1741320"/>
            <a:ext cx="238320" cy="180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4041720" y="1736640"/>
            <a:ext cx="0" cy="2286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2552760" y="5043600"/>
            <a:ext cx="237960" cy="1440"/>
          </a:xfrm>
          <a:custGeom>
            <a:avLst/>
            <a:gdLst/>
            <a:ahLst/>
            <a:rect l="l" t="t" r="r" b="b"/>
            <a:pathLst>
              <a:path w="150" h="0">
                <a:moveTo>
                  <a:pt x="0" y="0"/>
                </a:moveTo>
                <a:lnTo>
                  <a:pt x="150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2673360" y="5043600"/>
            <a:ext cx="3240" cy="139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7" name=""/>
          <p:cNvGrpSpPr/>
          <p:nvPr/>
        </p:nvGrpSpPr>
        <p:grpSpPr>
          <a:xfrm>
            <a:off x="2271960" y="2120760"/>
            <a:ext cx="2322720" cy="1352520"/>
            <a:chOff x="2271960" y="2120760"/>
            <a:chExt cx="2322720" cy="1352520"/>
          </a:xfrm>
        </p:grpSpPr>
        <p:pic>
          <p:nvPicPr>
            <p:cNvPr id="488" name="" descr=""/>
            <p:cNvPicPr/>
            <p:nvPr/>
          </p:nvPicPr>
          <p:blipFill>
            <a:blip r:embed="rId1"/>
            <a:stretch/>
          </p:blipFill>
          <p:spPr>
            <a:xfrm>
              <a:off x="2573280" y="3033720"/>
              <a:ext cx="1459080" cy="439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89" name="" descr=""/>
            <p:cNvPicPr/>
            <p:nvPr/>
          </p:nvPicPr>
          <p:blipFill>
            <a:blip r:embed="rId2"/>
            <a:srcRect l="0" t="15730" r="2262" b="15730"/>
            <a:stretch/>
          </p:blipFill>
          <p:spPr>
            <a:xfrm>
              <a:off x="2573280" y="2606760"/>
              <a:ext cx="1468440" cy="3808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90" name=""/>
            <p:cNvSpPr/>
            <p:nvPr/>
          </p:nvSpPr>
          <p:spPr>
            <a:xfrm>
              <a:off x="2271960" y="268920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70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2271960" y="32068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0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4102920" y="2744640"/>
              <a:ext cx="47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oxO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4103280" y="3162240"/>
              <a:ext cx="491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2462040" y="2789280"/>
              <a:ext cx="86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2462040" y="3313080"/>
              <a:ext cx="86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2582640" y="2378160"/>
              <a:ext cx="4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3016440" y="23781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#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3384720" y="23781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#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3734280" y="23781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#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3044880" y="2382840"/>
              <a:ext cx="971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2943720" y="2120760"/>
              <a:ext cx="1163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oxO1-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2" name=""/>
          <p:cNvSpPr/>
          <p:nvPr/>
        </p:nvSpPr>
        <p:spPr>
          <a:xfrm>
            <a:off x="573840" y="1158840"/>
            <a:ext cx="234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S-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825480" y="4102200"/>
            <a:ext cx="5492880" cy="77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estern blot showing the gene silencing efficacies of different FoxO1 siRNA sequences. FoxO1 siRNAs #2 and #3 were used in the formal experiments. NC, non-targeting control RNA.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01T07:10:59Z</dcterms:created>
  <dc:creator>fjiang</dc:creator>
  <dc:description/>
  <dc:language>en-US</dc:language>
  <cp:lastModifiedBy>penghualin</cp:lastModifiedBy>
  <dcterms:modified xsi:type="dcterms:W3CDTF">2015-05-23T08:27:27Z</dcterms:modified>
  <cp:revision>82</cp:revision>
  <dc:subject/>
  <dc:title>Slide 1</dc:title>
</cp:coreProperties>
</file>